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9" r:id="rId2"/>
  </p:sldIdLst>
  <p:sldSz cx="9144000" cy="6858000" type="screen4x3"/>
  <p:notesSz cx="9939338" cy="6807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294" autoAdjust="0"/>
    <p:restoredTop sz="61835" autoAdjust="0"/>
  </p:normalViewPr>
  <p:slideViewPr>
    <p:cSldViewPr snapToGrid="0">
      <p:cViewPr varScale="1">
        <p:scale>
          <a:sx n="68" d="100"/>
          <a:sy n="68" d="100"/>
        </p:scale>
        <p:origin x="2748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7046" cy="34154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9992" y="1"/>
            <a:ext cx="4307046" cy="34154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B7F58F-AC56-4FBF-8A41-91BAC14593A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438525" y="850900"/>
            <a:ext cx="3062288" cy="22971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3934" y="3275965"/>
            <a:ext cx="7951470" cy="26803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65659"/>
            <a:ext cx="4307046" cy="3415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9992" y="6465659"/>
            <a:ext cx="4307046" cy="3415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FFC4C6-D503-4663-8862-A279B0AE57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23654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b="1" dirty="0"/>
              <a:t>Supplement figure 3. </a:t>
            </a:r>
            <a:r>
              <a:rPr kumimoji="1" lang="en-US" altLang="ja-JP" b="0" dirty="0"/>
              <a:t>Survival curves </a:t>
            </a:r>
            <a:r>
              <a:rPr kumimoji="1" lang="en-US" altLang="ja-JP" dirty="0"/>
              <a:t>for 3-year IPF-related mortality </a:t>
            </a:r>
            <a:r>
              <a:rPr kumimoji="1" lang="en-US" altLang="ja-JP" b="0" dirty="0"/>
              <a:t>according to CCIS and </a:t>
            </a:r>
            <a:r>
              <a:rPr lang="en-GB" sz="1800" kern="1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anti-fibrotic agent among 130 patients</a:t>
            </a:r>
            <a:endParaRPr kumimoji="1" lang="en-US" altLang="ja-JP" b="0" dirty="0"/>
          </a:p>
          <a:p>
            <a:r>
              <a:rPr kumimoji="1" lang="en-US" altLang="ja-JP" b="0" dirty="0"/>
              <a:t>Comparison of the </a:t>
            </a:r>
            <a:r>
              <a:rPr kumimoji="1" lang="en-US" altLang="ja-JP" dirty="0"/>
              <a:t>curves by log-rank test in 130 patients according to CCIS group (A), and according to CCIS group in patients treated with </a:t>
            </a:r>
            <a:r>
              <a:rPr kumimoji="1" lang="en-US" altLang="ja-JP" dirty="0" err="1"/>
              <a:t>nintedanib</a:t>
            </a:r>
            <a:r>
              <a:rPr kumimoji="1" lang="en-US" altLang="ja-JP" dirty="0"/>
              <a:t> (B) and pirfenidone (C) showed no significant difference (P = 0.30, P = 0.21, and P = 0.91, respectively). </a:t>
            </a:r>
            <a:endParaRPr kumimoji="1" lang="en-US" altLang="ja-JP" b="1" dirty="0"/>
          </a:p>
          <a:p>
            <a:r>
              <a:rPr kumimoji="1" lang="en-US" altLang="ja-JP" b="1" dirty="0"/>
              <a:t>Abbreviations: </a:t>
            </a:r>
            <a:r>
              <a:rPr kumimoji="1" lang="en-US" altLang="ja-JP" dirty="0"/>
              <a:t>CCIS, </a:t>
            </a:r>
            <a:r>
              <a:rPr kumimoji="1" lang="en-US" altLang="ja-JP" dirty="0" err="1"/>
              <a:t>Charlson</a:t>
            </a:r>
            <a:r>
              <a:rPr kumimoji="1" lang="en-US" altLang="ja-JP" dirty="0"/>
              <a:t> Comorbidity Index Score; IPF, idiopathic pulmonary fibrosis.</a:t>
            </a: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93FFC4C6-D503-4663-8862-A279B0AE5794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4462895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375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215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2092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0743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667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100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777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7516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5233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762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100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D55805-7B7D-441B-9DD8-D76EA3F1F94A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856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図 24">
            <a:extLst>
              <a:ext uri="{FF2B5EF4-FFF2-40B4-BE49-F238E27FC236}">
                <a16:creationId xmlns:a16="http://schemas.microsoft.com/office/drawing/2014/main" id="{97D876AA-BF7D-74AC-C275-FA60BFED43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5286" y="3967046"/>
            <a:ext cx="3444538" cy="2370025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1A95BDE0-EAC9-F9DB-3F90-0D42D20C5EC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4176" y="3967047"/>
            <a:ext cx="3444538" cy="2370025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35FBBB49-DF37-BEA4-4B21-7C953D24470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49731" y="1069487"/>
            <a:ext cx="3444538" cy="2370025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B9278E9-7B39-A149-F398-838D5393A870}"/>
              </a:ext>
            </a:extLst>
          </p:cNvPr>
          <p:cNvSpPr txBox="1"/>
          <p:nvPr/>
        </p:nvSpPr>
        <p:spPr>
          <a:xfrm>
            <a:off x="1206845" y="0"/>
            <a:ext cx="67303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dirty="0">
                <a:solidFill>
                  <a:prstClr val="black"/>
                </a:solidFill>
                <a:latin typeface="Calibri"/>
                <a:ea typeface="游ゴシック" panose="020B0400000000000000" pitchFamily="50" charset="-128"/>
                <a:cs typeface="Arial" panose="020B0604020202020204" pitchFamily="34" charset="0"/>
              </a:rPr>
              <a:t>Supplement figure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Arial" panose="020B0604020202020204" pitchFamily="34" charset="0"/>
              </a:rPr>
              <a:t> 3. Survival curves for 3-year IPF-related </a:t>
            </a:r>
            <a:r>
              <a:rPr kumimoji="1" lang="en-US" altLang="ja-JP" b="1" dirty="0">
                <a:solidFill>
                  <a:prstClr val="black"/>
                </a:solidFill>
                <a:latin typeface="Calibri"/>
                <a:ea typeface="游ゴシック" panose="020B0400000000000000" pitchFamily="50" charset="-128"/>
                <a:cs typeface="Arial" panose="020B0604020202020204" pitchFamily="34" charset="0"/>
              </a:rPr>
              <a:t>mortality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Arial" panose="020B0604020202020204" pitchFamily="34" charset="0"/>
              </a:rPr>
              <a:t>according to CCIS and anti-fibrotic agent among 130 patients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80883B3-A7E0-C6FE-2695-B93E773DB98A}"/>
              </a:ext>
            </a:extLst>
          </p:cNvPr>
          <p:cNvSpPr txBox="1"/>
          <p:nvPr/>
        </p:nvSpPr>
        <p:spPr>
          <a:xfrm>
            <a:off x="1077213" y="5220221"/>
            <a:ext cx="17393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Low CCIS group (N = 46)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High CCIS group (N = 24)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P = 0.21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6E2C485-1AF0-DFF7-746B-258616A8CA44}"/>
              </a:ext>
            </a:extLst>
          </p:cNvPr>
          <p:cNvSpPr txBox="1"/>
          <p:nvPr/>
        </p:nvSpPr>
        <p:spPr>
          <a:xfrm>
            <a:off x="5832963" y="5208277"/>
            <a:ext cx="174541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Low CCIS group (N = 42)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High CCIS group (N = 18)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P = 0.91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A3F1C1E-9FF4-BC22-0D65-D339C8531FCF}"/>
              </a:ext>
            </a:extLst>
          </p:cNvPr>
          <p:cNvSpPr txBox="1"/>
          <p:nvPr/>
        </p:nvSpPr>
        <p:spPr>
          <a:xfrm rot="16200000">
            <a:off x="99560" y="4796198"/>
            <a:ext cx="1113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Survival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rate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CF9696B-4822-C676-B99C-EF8DDD4A7BB9}"/>
              </a:ext>
            </a:extLst>
          </p:cNvPr>
          <p:cNvSpPr txBox="1"/>
          <p:nvPr/>
        </p:nvSpPr>
        <p:spPr>
          <a:xfrm>
            <a:off x="1451654" y="6059391"/>
            <a:ext cx="17109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Time to </a:t>
            </a:r>
            <a:r>
              <a:rPr kumimoji="1" lang="en-US" altLang="ja-JP" sz="1400" b="1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death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(days)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9575963-5ABB-CA5B-6F86-F2ACF316D4A8}"/>
              </a:ext>
            </a:extLst>
          </p:cNvPr>
          <p:cNvSpPr txBox="1"/>
          <p:nvPr/>
        </p:nvSpPr>
        <p:spPr>
          <a:xfrm rot="16200000">
            <a:off x="4850668" y="4796198"/>
            <a:ext cx="1113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Survival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rate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3FDB09C-5385-8021-E161-5DDDC2104397}"/>
              </a:ext>
            </a:extLst>
          </p:cNvPr>
          <p:cNvSpPr txBox="1"/>
          <p:nvPr/>
        </p:nvSpPr>
        <p:spPr>
          <a:xfrm>
            <a:off x="6202763" y="6059391"/>
            <a:ext cx="17109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Time to </a:t>
            </a:r>
            <a:r>
              <a:rPr kumimoji="1" lang="en-US" altLang="ja-JP" sz="1400" b="1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death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(days)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2BF2456-4194-4121-9F73-7E1EEF6F742B}"/>
              </a:ext>
            </a:extLst>
          </p:cNvPr>
          <p:cNvSpPr txBox="1"/>
          <p:nvPr/>
        </p:nvSpPr>
        <p:spPr>
          <a:xfrm>
            <a:off x="474176" y="3581955"/>
            <a:ext cx="2102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B. </a:t>
            </a:r>
            <a:r>
              <a:rPr kumimoji="1" lang="en-US" altLang="ja-JP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Nintedanib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group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E6A6D54-599F-AF63-8F14-E5F1CBC7E079}"/>
              </a:ext>
            </a:extLst>
          </p:cNvPr>
          <p:cNvSpPr txBox="1"/>
          <p:nvPr/>
        </p:nvSpPr>
        <p:spPr>
          <a:xfrm>
            <a:off x="5220657" y="3581955"/>
            <a:ext cx="21430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C. Pirfenidone group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A0BA946-7985-70D2-88AB-D2103CA5824D}"/>
              </a:ext>
            </a:extLst>
          </p:cNvPr>
          <p:cNvSpPr txBox="1"/>
          <p:nvPr/>
        </p:nvSpPr>
        <p:spPr>
          <a:xfrm>
            <a:off x="3442375" y="2313997"/>
            <a:ext cx="17393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Low CCIS group (N = 88)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High CCIS group (N = 42)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P = 0.30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648AC15-D6B1-65A9-8549-87A645CEB536}"/>
              </a:ext>
            </a:extLst>
          </p:cNvPr>
          <p:cNvSpPr txBox="1"/>
          <p:nvPr/>
        </p:nvSpPr>
        <p:spPr>
          <a:xfrm rot="16200000">
            <a:off x="2475115" y="1898637"/>
            <a:ext cx="1113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Survival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rate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B46CF4D-0EFB-7B82-0809-3063880A751F}"/>
              </a:ext>
            </a:extLst>
          </p:cNvPr>
          <p:cNvSpPr txBox="1"/>
          <p:nvPr/>
        </p:nvSpPr>
        <p:spPr>
          <a:xfrm>
            <a:off x="3827210" y="3161830"/>
            <a:ext cx="17109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Time to </a:t>
            </a:r>
            <a:r>
              <a:rPr kumimoji="1" lang="en-US" altLang="ja-JP" sz="1400" b="1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death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(days)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C464CF1-1DEE-91B7-4E64-1F1D7D2BA803}"/>
              </a:ext>
            </a:extLst>
          </p:cNvPr>
          <p:cNvSpPr txBox="1"/>
          <p:nvPr/>
        </p:nvSpPr>
        <p:spPr>
          <a:xfrm>
            <a:off x="2878015" y="700155"/>
            <a:ext cx="1523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. All patients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6457888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96</TotalTime>
  <Words>202</Words>
  <Application>Microsoft Office PowerPoint</Application>
  <PresentationFormat>画面に合わせる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原　悠</dc:creator>
  <cp:lastModifiedBy>原　悠</cp:lastModifiedBy>
  <cp:revision>10</cp:revision>
  <cp:lastPrinted>2023-03-25T22:56:31Z</cp:lastPrinted>
  <dcterms:created xsi:type="dcterms:W3CDTF">2022-10-17T23:58:32Z</dcterms:created>
  <dcterms:modified xsi:type="dcterms:W3CDTF">2023-09-07T00:58:46Z</dcterms:modified>
</cp:coreProperties>
</file>